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1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37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BFBFB"/>
    <a:srgbClr val="FFC08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2833802-FEF1-4C79-8D5D-14CF1EAF98D9}" styleName="淡色スタイル 2 - アクセント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</a:tcStyle>
    </a:band1H>
    <a:band1V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</a:tcBdr>
      </a:tcStyle>
    </a:band1V>
    <a:band2V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2"/>
        </a:fillRef>
      </a:tcStyle>
    </a:firstRow>
  </a:tblStyle>
  <a:tblStyle styleId="{21E4AEA4-8DFA-4A89-87EB-49C32662AFE0}" styleName="中間スタイル 2 - アクセント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9DCAF9ED-07DC-4A11-8D7F-57B35C25682E}" styleName="中間スタイル 1 - アクセント 2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2">
              <a:tint val="20000"/>
            </a:schemeClr>
          </a:solidFill>
        </a:fill>
      </a:tcStyle>
    </a:band1H>
    <a:band1V>
      <a:tcStyle>
        <a:tcBdr/>
        <a:fill>
          <a:solidFill>
            <a:schemeClr val="accent2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920" autoAdjust="0"/>
    <p:restoredTop sz="96318" autoAdjust="0"/>
  </p:normalViewPr>
  <p:slideViewPr>
    <p:cSldViewPr snapToGrid="0" showGuides="1">
      <p:cViewPr varScale="1">
        <p:scale>
          <a:sx n="93" d="100"/>
          <a:sy n="93" d="100"/>
        </p:scale>
        <p:origin x="165" y="60"/>
      </p:cViewPr>
      <p:guideLst>
        <p:guide orient="horz" pos="2137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3B4F76-D101-4478-A59E-24A65DEE2D74}" type="datetimeFigureOut">
              <a:rPr kumimoji="1" lang="ja-JP" altLang="en-US" smtClean="0"/>
              <a:t>2026/4/1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D13F9E7-91F4-41E4-8782-AA54A3F5EE3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689541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86A5B73-E66D-BA58-688B-EEF02092A67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848AAB36-4BA6-1EC8-E30E-41D0D0E8B73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C6CC3A3-5D12-314B-0E11-42652A1307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C58F8-D642-4320-A2F8-10EF1EC83CFB}" type="datetimeFigureOut">
              <a:rPr kumimoji="1" lang="ja-JP" altLang="en-US" smtClean="0"/>
              <a:t>2026/4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CCFEC9B-5B43-BB15-E06B-99F9A8F12B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99DB512-C055-9B9A-D8A1-DAE92025C1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1B38C-0B8E-4DA1-A142-B719652DF0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09957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D7D5221-C7E3-510B-0D52-92C43C5507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343903E-E062-19D7-0486-2BA74BF45DD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5222409-4106-772F-AB89-9CFC6F26C6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C58F8-D642-4320-A2F8-10EF1EC83CFB}" type="datetimeFigureOut">
              <a:rPr kumimoji="1" lang="ja-JP" altLang="en-US" smtClean="0"/>
              <a:t>2026/4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24D5A12-02D2-B54A-236C-CD11D26994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E7A8B64-4279-579A-32F4-35ABA93C62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1B38C-0B8E-4DA1-A142-B719652DF0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79411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A6252256-827C-74E5-1787-E13C2015BED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F6CA120A-DA0E-31ED-8E5B-4BBE39A4F31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8548FE9-DFDC-FB71-C7C1-ABC80F2B9C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C58F8-D642-4320-A2F8-10EF1EC83CFB}" type="datetimeFigureOut">
              <a:rPr kumimoji="1" lang="ja-JP" altLang="en-US" smtClean="0"/>
              <a:t>2026/4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FF89AE2-6BF7-4679-78D6-2B917D64CA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B88E182-FECD-822F-4E13-3B634B2E9C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1B38C-0B8E-4DA1-A142-B719652DF0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20974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00A724C-7024-6859-FA21-BB13E24D98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16A6809-2CAE-15FD-282E-8F518A2AA35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4E39DD6-8078-1035-129B-FE5118A8AB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C58F8-D642-4320-A2F8-10EF1EC83CFB}" type="datetimeFigureOut">
              <a:rPr kumimoji="1" lang="ja-JP" altLang="en-US" smtClean="0"/>
              <a:t>2026/4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1FF3530-7B7C-7E27-3F64-CFE574958B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1A4BAC6-7BD1-95A0-C54F-41E280FD8E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1B38C-0B8E-4DA1-A142-B719652DF0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99067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6F22D45-53B4-E55B-A373-A349CCE82C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0DEFB30-308D-EB98-32C3-330AFF46E1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489D3AA-BFD2-04FE-341D-B4A7D59EA3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C58F8-D642-4320-A2F8-10EF1EC83CFB}" type="datetimeFigureOut">
              <a:rPr kumimoji="1" lang="ja-JP" altLang="en-US" smtClean="0"/>
              <a:t>2026/4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6DBE35F-08BB-AF3E-8298-53FBFB8534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B33C32A-15BE-10D4-5CA0-5AEF79B3BA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1B38C-0B8E-4DA1-A142-B719652DF0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4328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22F956D-C646-BA78-3AAD-AFDAC57AE6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6FB416D-952C-4399-F76C-8B5E2600FB5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FEE9141-73EF-209B-25D8-8AD40A183D1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F945F83-4447-05EE-D44C-0145FE6CF8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C58F8-D642-4320-A2F8-10EF1EC83CFB}" type="datetimeFigureOut">
              <a:rPr kumimoji="1" lang="ja-JP" altLang="en-US" smtClean="0"/>
              <a:t>2026/4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D2BD4F9-2AC5-9778-DB9D-9F91B6B833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85D7CD1-C092-BD2A-43B3-2ACDE21D02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1B38C-0B8E-4DA1-A142-B719652DF0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65464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40E46A2-5397-3893-5747-0705E62A98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47A052F-0E8D-29ED-AAA5-A4F0740229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E9B1A22-0E1E-EDB6-6DE7-8490BB1E925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9A4C3EE1-0331-0E43-64BC-3DA9893D85C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A9EDFD60-182C-E5D2-1B75-02F43CE9587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E3D5D286-35A3-4D22-A09B-7E931E486F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C58F8-D642-4320-A2F8-10EF1EC83CFB}" type="datetimeFigureOut">
              <a:rPr kumimoji="1" lang="ja-JP" altLang="en-US" smtClean="0"/>
              <a:t>2026/4/13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7ACC7F0D-EF19-F027-EA0D-8C50C0615F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5CF6F75D-4969-8D3C-10CF-DF4632CDE7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1B38C-0B8E-4DA1-A142-B719652DF0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1784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C6B580D-47BD-7A55-2909-65ED8C0E82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82F1C052-F8FB-EC11-8C97-30FD455B90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C58F8-D642-4320-A2F8-10EF1EC83CFB}" type="datetimeFigureOut">
              <a:rPr kumimoji="1" lang="ja-JP" altLang="en-US" smtClean="0"/>
              <a:t>2026/4/13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E9DF1FB4-8E73-207D-ED2A-150C2CA3B0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9331C53D-D051-0879-0A54-770605CA00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1B38C-0B8E-4DA1-A142-B719652DF0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14385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D60D982A-FF5A-0F74-EBBA-F726CC55FB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C58F8-D642-4320-A2F8-10EF1EC83CFB}" type="datetimeFigureOut">
              <a:rPr kumimoji="1" lang="ja-JP" altLang="en-US" smtClean="0"/>
              <a:t>2026/4/13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1EBC8CF7-8613-F088-AAC1-6015D04F01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7202826B-3E32-8063-3476-DD61A3667A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1B38C-0B8E-4DA1-A142-B719652DF0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86052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15D056D-46E7-C3EC-F5D6-A72547DAA6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E9D3A1F-F668-3CD2-B741-7202E9C9F44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9E7F3DCC-9EFE-F5E3-4614-9955D0F45FF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2E4E076-C948-C0D2-6ED0-D7708510C3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C58F8-D642-4320-A2F8-10EF1EC83CFB}" type="datetimeFigureOut">
              <a:rPr kumimoji="1" lang="ja-JP" altLang="en-US" smtClean="0"/>
              <a:t>2026/4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D2C0AC8-9159-2DF8-EA5B-8423113D21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0F6CBD2-6040-9619-8FEB-50B8B7D998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1B38C-0B8E-4DA1-A142-B719652DF0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65569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8AFDBE2-974B-EEEB-316C-F467C0E1F4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0B912812-6927-08E9-88E0-114542BB68D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7FBB516-75BB-FAF7-CFD4-6D7706B4551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F83A911-D8F1-F3F5-C790-D3395C3E72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C58F8-D642-4320-A2F8-10EF1EC83CFB}" type="datetimeFigureOut">
              <a:rPr kumimoji="1" lang="ja-JP" altLang="en-US" smtClean="0"/>
              <a:t>2026/4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F4D87A3-BB51-F856-6CED-3448CC0997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A69F362-21AB-E837-07C8-507EB9DE39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1B38C-0B8E-4DA1-A142-B719652DF0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31683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D21175AC-C8B9-7987-179D-9FBD19AC86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85762F9-E0A8-7E75-0058-28229784BE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3CA7C3C-207E-03A6-50AA-0CC5149B776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37C58F8-D642-4320-A2F8-10EF1EC83CFB}" type="datetimeFigureOut">
              <a:rPr kumimoji="1" lang="ja-JP" altLang="en-US" smtClean="0"/>
              <a:t>2026/4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9EE0C43-5E0F-5817-42E9-C3FFAE917A6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2D17E5F-406A-B657-D664-F3CD4061417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321B38C-0B8E-4DA1-A142-B719652DF0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78302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CA797EE-E6C2-DA04-4D39-1D0AD66C1AF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F2A67894-BCC3-D723-1EB6-B70F3524CC5D}"/>
              </a:ext>
            </a:extLst>
          </p:cNvPr>
          <p:cNvSpPr txBox="1"/>
          <p:nvPr/>
        </p:nvSpPr>
        <p:spPr>
          <a:xfrm>
            <a:off x="1805034" y="4126300"/>
            <a:ext cx="8583912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: Detection of Lac-</a:t>
            </a:r>
            <a:r>
              <a:rPr kumimoji="1" lang="en-US" altLang="ja-JP" b="1" dirty="0" err="1">
                <a:latin typeface="Arial" panose="020B0604020202020204" pitchFamily="34" charset="0"/>
                <a:cs typeface="Arial" panose="020B0604020202020204" pitchFamily="34" charset="0"/>
              </a:rPr>
              <a:t>Phe</a:t>
            </a:r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 in portal vein plasma 15 min after oral administration</a:t>
            </a:r>
          </a:p>
          <a:p>
            <a:pPr algn="just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Mice were orally administered vehicle (saline, n = 4) or Lac-</a:t>
            </a:r>
            <a:r>
              <a:rPr kumimoji="1"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Phe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(300 </a:t>
            </a:r>
            <a:r>
              <a:rPr kumimoji="1" lang="el-GR" altLang="ja-JP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g/mouse, n = 4). Portal vein plasma was collected 15 min after oral administration of vehicle or Lac-</a:t>
            </a:r>
            <a:r>
              <a:rPr kumimoji="1"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Phe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, and Lac-</a:t>
            </a:r>
            <a:r>
              <a:rPr kumimoji="1"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Phe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-derived peak area was measured by LC-MS. *p &lt; 0.05 for t-tests. Data represent the mean ± SEM.</a:t>
            </a: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4E6F16B5-9426-CC33-3A4C-95ED0C92B42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47516" y="604257"/>
            <a:ext cx="4696968" cy="32247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390434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901</TotalTime>
  <Words>79</Words>
  <Application>Microsoft Office PowerPoint</Application>
  <PresentationFormat>ワイド画面</PresentationFormat>
  <Paragraphs>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乳酸フェニルアラニン(Lac-Phe)と脳機能制御</dc:title>
  <dc:creator>詩萌 鈴木</dc:creator>
  <cp:lastModifiedBy>KENTARO KANEKO</cp:lastModifiedBy>
  <cp:revision>238</cp:revision>
  <dcterms:created xsi:type="dcterms:W3CDTF">2024-07-07T02:36:58Z</dcterms:created>
  <dcterms:modified xsi:type="dcterms:W3CDTF">2026-04-13T02:12:55Z</dcterms:modified>
</cp:coreProperties>
</file>